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676E90-9583-4026-B5D7-BB3532B1C0D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2126A2-22B3-4D91-9814-1B089ADAF58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DC2790-D3C0-4CD5-BF41-3D9AAB5E216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F4EF55-5E22-4CF4-A04B-1BAAFCE57D9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3F4967-43CF-4403-892B-4FE8131644F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AFFE8C-04ED-4A0C-BCDA-EC16BF51DB8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96215B-CA5B-44D7-8D4D-42E37B0CB1B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8A1038-462E-49C8-97F6-3FF01439DCC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43EFEE-EF75-4BDD-AE31-387713046F0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8DD06B-42A2-4BE3-83E5-94F5D345A6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A63C43-5B97-4CDE-AABE-B5F3984E54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5400F3-804C-46E3-ACFA-F5BDC059B3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1F6B6AC-25DF-400D-B9CF-F54578A320C6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e 23"/>
          <p:cNvGrpSpPr/>
          <p:nvPr/>
        </p:nvGrpSpPr>
        <p:grpSpPr>
          <a:xfrm>
            <a:off x="146160" y="534960"/>
            <a:ext cx="8997840" cy="4659480"/>
            <a:chOff x="146160" y="534960"/>
            <a:chExt cx="8997840" cy="4659480"/>
          </a:xfrm>
        </p:grpSpPr>
        <p:pic>
          <p:nvPicPr>
            <p:cNvPr id="42" name="Picture 2" descr=""/>
            <p:cNvPicPr/>
            <p:nvPr/>
          </p:nvPicPr>
          <p:blipFill>
            <a:blip r:embed="rId1"/>
            <a:srcRect l="1814" t="10162" r="7040" b="0"/>
            <a:stretch/>
          </p:blipFill>
          <p:spPr>
            <a:xfrm>
              <a:off x="146160" y="600840"/>
              <a:ext cx="8997840" cy="4593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ZoneTexte 9"/>
            <p:cNvSpPr/>
            <p:nvPr/>
          </p:nvSpPr>
          <p:spPr>
            <a:xfrm>
              <a:off x="7040520" y="3748320"/>
              <a:ext cx="1611000" cy="459000"/>
            </a:xfrm>
            <a:prstGeom prst="rect">
              <a:avLst/>
            </a:prstGeom>
            <a:gradFill rotWithShape="0">
              <a:gsLst>
                <a:gs pos="0">
                  <a:srgbClr val="a3c4ff"/>
                </a:gs>
                <a:gs pos="100000">
                  <a:srgbClr val="e5eeff"/>
                </a:gs>
              </a:gsLst>
              <a:lin ang="16200000"/>
            </a:gradFill>
            <a:ln w="9360">
              <a:solidFill>
                <a:srgbClr val="4a7ebb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Reference Subculture,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ID to 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Calibri"/>
                </a:rPr>
                <a:t>S. pyogenes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ZoneTexte 10"/>
            <p:cNvSpPr/>
            <p:nvPr/>
          </p:nvSpPr>
          <p:spPr>
            <a:xfrm>
              <a:off x="7018200" y="534960"/>
              <a:ext cx="1998720" cy="824040"/>
            </a:xfrm>
            <a:prstGeom prst="rect">
              <a:avLst/>
            </a:prstGeom>
            <a:gradFill rotWithShape="0">
              <a:gsLst>
                <a:gs pos="0">
                  <a:srgbClr val="9eeaff"/>
                </a:gs>
                <a:gs pos="100000">
                  <a:srgbClr val="e4f9ff"/>
                </a:gs>
              </a:gsLst>
              <a:lin ang="16200000"/>
            </a:gradFill>
            <a:ln w="9360">
              <a:solidFill>
                <a:srgbClr val="46aac5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BCSP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Standard wash sequence +AF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Positive Blood culture,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No ID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ZoneTexte 11"/>
            <p:cNvSpPr/>
            <p:nvPr/>
          </p:nvSpPr>
          <p:spPr>
            <a:xfrm>
              <a:off x="7026840" y="2482920"/>
              <a:ext cx="1617840" cy="824040"/>
            </a:xfrm>
            <a:prstGeom prst="rect">
              <a:avLst/>
            </a:prstGeom>
            <a:gradFill rotWithShape="0">
              <a:gsLst>
                <a:gs pos="0">
                  <a:srgbClr val="c9b5e8"/>
                </a:gs>
                <a:gs pos="100000">
                  <a:srgbClr val="f0eaf9"/>
                </a:gs>
              </a:gsLst>
              <a:lin ang="16200000"/>
            </a:gradFill>
            <a:ln w="9360">
              <a:solidFill>
                <a:srgbClr val="7d60a0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BCSP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Additional washes + AF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Positive Blood culture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ID to 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Calibri"/>
                </a:rPr>
                <a:t>S. pyogene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ZoneTexte 12"/>
            <p:cNvSpPr/>
            <p:nvPr/>
          </p:nvSpPr>
          <p:spPr>
            <a:xfrm>
              <a:off x="5334120" y="1176120"/>
              <a:ext cx="1536480" cy="6415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Alpha Hemoglobin peaks (singly / doubly &amp; tri charged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47" name="Connecteur droit avec flèche 13"/>
            <p:cNvCxnSpPr/>
            <p:nvPr/>
          </p:nvCxnSpPr>
          <p:spPr>
            <a:xfrm>
              <a:off x="7020000" y="1799640"/>
              <a:ext cx="699120" cy="831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48" name="Connecteur droit avec flèche 14"/>
            <p:cNvCxnSpPr/>
            <p:nvPr/>
          </p:nvCxnSpPr>
          <p:spPr>
            <a:xfrm flipH="1" flipV="1">
              <a:off x="4656960" y="891720"/>
              <a:ext cx="616680" cy="26424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49" name="Connecteur droit avec flèche 18"/>
            <p:cNvCxnSpPr/>
            <p:nvPr/>
          </p:nvCxnSpPr>
          <p:spPr>
            <a:xfrm flipH="1">
              <a:off x="3614400" y="1431360"/>
              <a:ext cx="1645200" cy="1242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</p:grpSp>
      <p:sp>
        <p:nvSpPr>
          <p:cNvPr id="50" name="ZoneTexte 22"/>
          <p:cNvSpPr/>
          <p:nvPr/>
        </p:nvSpPr>
        <p:spPr>
          <a:xfrm>
            <a:off x="831240" y="227160"/>
            <a:ext cx="3455640" cy="30708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Calibri"/>
              </a:rPr>
              <a:t>BC spiked with Streptococcus pyogenes strai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1" name="Picture 9" descr=""/>
          <p:cNvPicPr/>
          <p:nvPr/>
        </p:nvPicPr>
        <p:blipFill>
          <a:blip r:embed="rId2"/>
          <a:stretch/>
        </p:blipFill>
        <p:spPr>
          <a:xfrm>
            <a:off x="3276720" y="5987880"/>
            <a:ext cx="5541840" cy="730440"/>
          </a:xfrm>
          <a:prstGeom prst="rect">
            <a:avLst/>
          </a:prstGeom>
          <a:ln w="0">
            <a:noFill/>
          </a:ln>
        </p:spPr>
      </p:pic>
      <p:sp>
        <p:nvSpPr>
          <p:cNvPr id="52" name="ZoneTexte 2"/>
          <p:cNvSpPr/>
          <p:nvPr/>
        </p:nvSpPr>
        <p:spPr>
          <a:xfrm>
            <a:off x="219240" y="5084640"/>
            <a:ext cx="815760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S1 : MS spectra obtained with Vitek MS after extraction with BCSP prototype :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cubation on BacT/Alert 3D system ,  SA Bottle (Ref 259789 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rotocol modification : addition of a 2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nd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washing step in W1 + vertical movement of  filter wand (FW) during all the washing step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 of formic acid (FA) before CHCA on MALDI-TOF MS slid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1-22T14:16:56Z</dcterms:created>
  <dc:creator>PERROT Nadine</dc:creator>
  <dc:description/>
  <dc:language>en-US</dc:language>
  <cp:lastModifiedBy>BROYER Patrick</cp:lastModifiedBy>
  <dcterms:modified xsi:type="dcterms:W3CDTF">2018-04-27T13:37:20Z</dcterms:modified>
  <cp:revision>24</cp:revision>
  <dc:subject/>
  <dc:title>Présentation PowerPoint</dc:title>
</cp:coreProperties>
</file>